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7" d="100"/>
          <a:sy n="67" d="100"/>
        </p:scale>
        <p:origin x="-1236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556327082313832"/>
          <c:y val="4.7979916301482357E-2"/>
          <c:w val="0.79911872050634769"/>
          <c:h val="0.76010288456558894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trendline>
            <c:spPr>
              <a:ln w="25400">
                <a:solidFill>
                  <a:srgbClr val="000000"/>
                </a:solidFill>
                <a:prstDash val="solid"/>
              </a:ln>
            </c:spPr>
            <c:trendlineType val="linear"/>
            <c:dispRSqr val="1"/>
            <c:dispEq val="0"/>
            <c:trendlineLbl>
              <c:layout>
                <c:manualLayout>
                  <c:x val="9.0701029351794332E-2"/>
                  <c:y val="0.58178972060313727"/>
                </c:manualLayout>
              </c:layout>
              <c:numFmt formatCode="0.00" sourceLinked="0"/>
              <c:spPr>
                <a:noFill/>
                <a:ln w="25400">
                  <a:noFill/>
                </a:ln>
              </c:spPr>
            </c:trendlineLbl>
          </c:trendline>
          <c:trendline>
            <c:spPr>
              <a:ln w="25400">
                <a:solidFill>
                  <a:srgbClr val="000000"/>
                </a:solidFill>
                <a:prstDash val="solid"/>
              </a:ln>
            </c:spPr>
            <c:trendlineType val="linear"/>
            <c:dispRSqr val="0"/>
            <c:dispEq val="1"/>
            <c:trendlineLbl>
              <c:layout>
                <c:manualLayout>
                  <c:x val="9.8499060821735387E-2"/>
                  <c:y val="0.64956968655304415"/>
                </c:manualLayout>
              </c:layout>
              <c:numFmt formatCode="0.00" sourceLinked="0"/>
              <c:spPr>
                <a:noFill/>
                <a:ln w="25400">
                  <a:noFill/>
                </a:ln>
              </c:spPr>
            </c:trendlineLbl>
          </c:trendline>
          <c:xVal>
            <c:numRef>
              <c:f>'P-result (ADJUST)'!$X$2:$X$31</c:f>
              <c:numCache>
                <c:formatCode>0.00</c:formatCode>
                <c:ptCount val="30"/>
                <c:pt idx="0">
                  <c:v>2.5576409194566083</c:v>
                </c:pt>
                <c:pt idx="1">
                  <c:v>2.6778719028498674</c:v>
                </c:pt>
                <c:pt idx="2">
                  <c:v>2.4242345883326437</c:v>
                </c:pt>
                <c:pt idx="3">
                  <c:v>2.2949420769549027</c:v>
                </c:pt>
                <c:pt idx="4">
                  <c:v>3.0852578831668334</c:v>
                </c:pt>
                <c:pt idx="5">
                  <c:v>2.3734411499823187</c:v>
                </c:pt>
                <c:pt idx="6">
                  <c:v>2.9831324545649327</c:v>
                </c:pt>
                <c:pt idx="7">
                  <c:v>2.7515047291487531</c:v>
                </c:pt>
                <c:pt idx="8">
                  <c:v>2.3860705073086841</c:v>
                </c:pt>
                <c:pt idx="9">
                  <c:v>1.9303587631744259</c:v>
                </c:pt>
                <c:pt idx="10">
                  <c:v>1.8976408180358766</c:v>
                </c:pt>
                <c:pt idx="11">
                  <c:v>3.0751263355151557</c:v>
                </c:pt>
                <c:pt idx="12">
                  <c:v>2.4645416840590779</c:v>
                </c:pt>
                <c:pt idx="13">
                  <c:v>1.8521360420381965</c:v>
                </c:pt>
                <c:pt idx="14">
                  <c:v>2.715703214374217</c:v>
                </c:pt>
                <c:pt idx="15">
                  <c:v>2.3231992341716934</c:v>
                </c:pt>
                <c:pt idx="16">
                  <c:v>1.9733546411537266</c:v>
                </c:pt>
                <c:pt idx="17">
                  <c:v>2.0835979171958345</c:v>
                </c:pt>
                <c:pt idx="18">
                  <c:v>2.2534763480450923</c:v>
                </c:pt>
                <c:pt idx="19">
                  <c:v>2.01048951048951</c:v>
                </c:pt>
                <c:pt idx="20">
                  <c:v>1.7591783216783214</c:v>
                </c:pt>
                <c:pt idx="21">
                  <c:v>2.2139364662178536</c:v>
                </c:pt>
                <c:pt idx="22">
                  <c:v>1.961570651415818</c:v>
                </c:pt>
                <c:pt idx="23">
                  <c:v>2.3529996750196673</c:v>
                </c:pt>
                <c:pt idx="24">
                  <c:v>1.9645327475400054</c:v>
                </c:pt>
                <c:pt idx="25">
                  <c:v>1.813520547630127</c:v>
                </c:pt>
                <c:pt idx="26">
                  <c:v>2.6086581579855119</c:v>
                </c:pt>
                <c:pt idx="27">
                  <c:v>2.7811314246291823</c:v>
                </c:pt>
                <c:pt idx="28">
                  <c:v>2.6939655172413794</c:v>
                </c:pt>
                <c:pt idx="29">
                  <c:v>2.9849137931034484</c:v>
                </c:pt>
              </c:numCache>
            </c:numRef>
          </c:xVal>
          <c:yVal>
            <c:numRef>
              <c:f>'P-result (ADJUST)'!$T$2:$T$31</c:f>
              <c:numCache>
                <c:formatCode>0.00</c:formatCode>
                <c:ptCount val="30"/>
                <c:pt idx="0">
                  <c:v>2.6519751801659206</c:v>
                </c:pt>
                <c:pt idx="1">
                  <c:v>2.5583158274630096</c:v>
                </c:pt>
                <c:pt idx="2">
                  <c:v>2.3216457608202878</c:v>
                </c:pt>
                <c:pt idx="3">
                  <c:v>2.5744378015846112</c:v>
                </c:pt>
                <c:pt idx="4">
                  <c:v>2.9360930414628639</c:v>
                </c:pt>
                <c:pt idx="5">
                  <c:v>2.5992607607010849</c:v>
                </c:pt>
                <c:pt idx="6">
                  <c:v>2.9789084583605132</c:v>
                </c:pt>
                <c:pt idx="7">
                  <c:v>2.6959137148745773</c:v>
                </c:pt>
                <c:pt idx="8">
                  <c:v>2.3768464353135643</c:v>
                </c:pt>
                <c:pt idx="9">
                  <c:v>1.8990463586392061</c:v>
                </c:pt>
                <c:pt idx="10">
                  <c:v>1.9907100199071006</c:v>
                </c:pt>
                <c:pt idx="11">
                  <c:v>2.8054348049422835</c:v>
                </c:pt>
                <c:pt idx="12">
                  <c:v>2.8224833875553963</c:v>
                </c:pt>
                <c:pt idx="13">
                  <c:v>2.0238638587188111</c:v>
                </c:pt>
                <c:pt idx="14">
                  <c:v>2.7310821154628062</c:v>
                </c:pt>
                <c:pt idx="15">
                  <c:v>2.293912082857597</c:v>
                </c:pt>
                <c:pt idx="16">
                  <c:v>2.0028329689955804</c:v>
                </c:pt>
                <c:pt idx="17">
                  <c:v>2.1519088228261736</c:v>
                </c:pt>
                <c:pt idx="18">
                  <c:v>2.0800646557776079</c:v>
                </c:pt>
                <c:pt idx="19">
                  <c:v>1.9958526148279583</c:v>
                </c:pt>
                <c:pt idx="20">
                  <c:v>1.8987498182824472</c:v>
                </c:pt>
                <c:pt idx="21">
                  <c:v>2.0914416945116656</c:v>
                </c:pt>
                <c:pt idx="22">
                  <c:v>2.0976008232303829</c:v>
                </c:pt>
                <c:pt idx="23">
                  <c:v>2.2260365572720193</c:v>
                </c:pt>
                <c:pt idx="24">
                  <c:v>2.0627963198289536</c:v>
                </c:pt>
                <c:pt idx="25">
                  <c:v>1.8862470694008442</c:v>
                </c:pt>
                <c:pt idx="26">
                  <c:v>2.9315566323440341</c:v>
                </c:pt>
                <c:pt idx="27">
                  <c:v>2.9984488218402507</c:v>
                </c:pt>
                <c:pt idx="28">
                  <c:v>2.8468866157588066</c:v>
                </c:pt>
                <c:pt idx="29">
                  <c:v>2.980827755809479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P-result (ADJUST)'!$W$1</c:f>
              <c:strCache>
                <c:ptCount val="1"/>
                <c:pt idx="0">
                  <c:v>Peff90%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rgbClr val="FF00FF"/>
              </a:solidFill>
              <a:ln>
                <a:solidFill>
                  <a:srgbClr val="FF00FF"/>
                </a:solidFill>
                <a:prstDash val="solid"/>
              </a:ln>
            </c:spPr>
          </c:marker>
          <c:trendline>
            <c:spPr>
              <a:ln w="25400">
                <a:solidFill>
                  <a:srgbClr val="000000"/>
                </a:solidFill>
                <a:prstDash val="solid"/>
              </a:ln>
            </c:spPr>
            <c:trendlineType val="linear"/>
            <c:dispRSqr val="1"/>
            <c:dispEq val="0"/>
            <c:trendlineLbl>
              <c:layout>
                <c:manualLayout>
                  <c:x val="7.8308454328865879E-2"/>
                  <c:y val="0.27535489387290396"/>
                </c:manualLayout>
              </c:layout>
              <c:numFmt formatCode="General" sourceLinked="0"/>
              <c:spPr>
                <a:noFill/>
                <a:ln w="25400">
                  <a:noFill/>
                </a:ln>
              </c:spPr>
            </c:trendlineLbl>
          </c:trendline>
          <c:xVal>
            <c:numRef>
              <c:f>'P-result (ADJUST)'!$T$2:$T$31</c:f>
              <c:numCache>
                <c:formatCode>0.00</c:formatCode>
                <c:ptCount val="30"/>
                <c:pt idx="0">
                  <c:v>2.6519751801659206</c:v>
                </c:pt>
                <c:pt idx="1">
                  <c:v>2.5583158274630096</c:v>
                </c:pt>
                <c:pt idx="2">
                  <c:v>2.3216457608202878</c:v>
                </c:pt>
                <c:pt idx="3">
                  <c:v>2.5744378015846112</c:v>
                </c:pt>
                <c:pt idx="4">
                  <c:v>2.9360930414628639</c:v>
                </c:pt>
                <c:pt idx="5">
                  <c:v>2.5992607607010849</c:v>
                </c:pt>
                <c:pt idx="6">
                  <c:v>2.9789084583605132</c:v>
                </c:pt>
                <c:pt idx="7">
                  <c:v>2.6959137148745773</c:v>
                </c:pt>
                <c:pt idx="8">
                  <c:v>2.3768464353135643</c:v>
                </c:pt>
                <c:pt idx="9">
                  <c:v>1.8990463586392061</c:v>
                </c:pt>
                <c:pt idx="10">
                  <c:v>1.9907100199071006</c:v>
                </c:pt>
                <c:pt idx="11">
                  <c:v>2.8054348049422835</c:v>
                </c:pt>
                <c:pt idx="12">
                  <c:v>2.8224833875553963</c:v>
                </c:pt>
                <c:pt idx="13">
                  <c:v>2.0238638587188111</c:v>
                </c:pt>
                <c:pt idx="14">
                  <c:v>2.7310821154628062</c:v>
                </c:pt>
                <c:pt idx="15">
                  <c:v>2.293912082857597</c:v>
                </c:pt>
                <c:pt idx="16">
                  <c:v>2.0028329689955804</c:v>
                </c:pt>
                <c:pt idx="17">
                  <c:v>2.1519088228261736</c:v>
                </c:pt>
                <c:pt idx="18">
                  <c:v>2.0800646557776079</c:v>
                </c:pt>
                <c:pt idx="19">
                  <c:v>1.9958526148279583</c:v>
                </c:pt>
                <c:pt idx="20">
                  <c:v>1.8987498182824472</c:v>
                </c:pt>
                <c:pt idx="21">
                  <c:v>2.0914416945116656</c:v>
                </c:pt>
                <c:pt idx="22">
                  <c:v>2.0976008232303829</c:v>
                </c:pt>
                <c:pt idx="23">
                  <c:v>2.2260365572720193</c:v>
                </c:pt>
                <c:pt idx="24">
                  <c:v>2.0627963198289536</c:v>
                </c:pt>
                <c:pt idx="25">
                  <c:v>1.8862470694008442</c:v>
                </c:pt>
                <c:pt idx="26">
                  <c:v>2.9315566323440341</c:v>
                </c:pt>
                <c:pt idx="27">
                  <c:v>2.9984488218402507</c:v>
                </c:pt>
                <c:pt idx="28">
                  <c:v>2.8468866157588066</c:v>
                </c:pt>
                <c:pt idx="29">
                  <c:v>2.9808277558094796</c:v>
                </c:pt>
              </c:numCache>
            </c:numRef>
          </c:xVal>
          <c:yVal>
            <c:numRef>
              <c:f>'P-result (ADJUST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4180352"/>
        <c:axId val="99452416"/>
      </c:scatterChart>
      <c:valAx>
        <c:axId val="84180352"/>
        <c:scaling>
          <c:orientation val="minMax"/>
          <c:max val="3.3"/>
          <c:min val="1.6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UE estimated based on P supplied</a:t>
                </a:r>
              </a:p>
            </c:rich>
          </c:tx>
          <c:layout>
            <c:manualLayout>
              <c:xMode val="edge"/>
              <c:yMode val="edge"/>
              <c:x val="0.26398002244668911"/>
              <c:y val="0.93591136363636351"/>
            </c:manualLayout>
          </c:layout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99452416"/>
        <c:crosses val="autoZero"/>
        <c:crossBetween val="midCat"/>
        <c:majorUnit val="0.4"/>
      </c:valAx>
      <c:valAx>
        <c:axId val="99452416"/>
        <c:scaling>
          <c:orientation val="minMax"/>
          <c:max val="3.2"/>
          <c:min val="1.6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UE measured based on tissue P concentrations</a:t>
                </a:r>
              </a:p>
            </c:rich>
          </c:tx>
          <c:layout>
            <c:manualLayout>
              <c:xMode val="edge"/>
              <c:yMode val="edge"/>
              <c:x val="1.1854320987654319E-2"/>
              <c:y val="5.1779545454545446E-2"/>
            </c:manualLayout>
          </c:layout>
          <c:overlay val="0"/>
          <c:spPr>
            <a:noFill/>
            <a:ln w="25400">
              <a:noFill/>
            </a:ln>
          </c:spPr>
        </c:title>
        <c:numFmt formatCode="_(* #,##0.0_);_(* \(#,##0.0\);_(* &quot;-&quot;_);_(@_)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84180352"/>
        <c:crosses val="autoZero"/>
        <c:crossBetween val="midCat"/>
        <c:majorUnit val="0.4"/>
      </c:valAx>
      <c:spPr>
        <a:noFill/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556327082313832"/>
          <c:y val="4.7979916301482357E-2"/>
          <c:w val="0.79911872050634769"/>
          <c:h val="0.76010288456558894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000080"/>
              </a:solidFill>
              <a:ln>
                <a:solidFill>
                  <a:srgbClr val="000080"/>
                </a:solidFill>
                <a:prstDash val="solid"/>
              </a:ln>
            </c:spPr>
          </c:marker>
          <c:trendline>
            <c:spPr>
              <a:ln w="25400">
                <a:solidFill>
                  <a:srgbClr val="000000"/>
                </a:solidFill>
                <a:prstDash val="solid"/>
              </a:ln>
            </c:spPr>
            <c:trendlineType val="linear"/>
            <c:dispRSqr val="1"/>
            <c:dispEq val="0"/>
            <c:trendlineLbl>
              <c:layout>
                <c:manualLayout>
                  <c:x val="0.17167587320173774"/>
                  <c:y val="0.4900492331662587"/>
                </c:manualLayout>
              </c:layout>
              <c:numFmt formatCode="0.00" sourceLinked="0"/>
              <c:spPr>
                <a:noFill/>
                <a:ln w="25400">
                  <a:noFill/>
                </a:ln>
              </c:spPr>
            </c:trendlineLbl>
          </c:trendline>
          <c:trendline>
            <c:spPr>
              <a:ln w="25400">
                <a:solidFill>
                  <a:srgbClr val="000000"/>
                </a:solidFill>
                <a:prstDash val="solid"/>
              </a:ln>
            </c:spPr>
            <c:trendlineType val="linear"/>
            <c:dispRSqr val="0"/>
            <c:dispEq val="1"/>
            <c:trendlineLbl>
              <c:layout>
                <c:manualLayout>
                  <c:x val="0.17512309989497402"/>
                  <c:y val="0.54678554842871041"/>
                </c:manualLayout>
              </c:layout>
              <c:numFmt formatCode="0.00" sourceLinked="0"/>
              <c:spPr>
                <a:noFill/>
                <a:ln w="25400">
                  <a:noFill/>
                </a:ln>
              </c:spPr>
            </c:trendlineLbl>
          </c:trendline>
          <c:xVal>
            <c:numRef>
              <c:f>Sheet1!$O$2:$O$63</c:f>
              <c:numCache>
                <c:formatCode>0.00</c:formatCode>
                <c:ptCount val="62"/>
                <c:pt idx="0">
                  <c:v>1.6130551500023547</c:v>
                </c:pt>
                <c:pt idx="1">
                  <c:v>1.2716055197098854</c:v>
                </c:pt>
                <c:pt idx="2">
                  <c:v>1.6017212526894573</c:v>
                </c:pt>
                <c:pt idx="3">
                  <c:v>1.5897681090126703</c:v>
                </c:pt>
                <c:pt idx="4">
                  <c:v>1.8247310299066306</c:v>
                </c:pt>
                <c:pt idx="5">
                  <c:v>1.6825441964074126</c:v>
                </c:pt>
                <c:pt idx="6">
                  <c:v>1.8829327258356967</c:v>
                </c:pt>
                <c:pt idx="7">
                  <c:v>1.7202101445906364</c:v>
                </c:pt>
                <c:pt idx="8">
                  <c:v>1.731318141406579</c:v>
                </c:pt>
                <c:pt idx="9">
                  <c:v>1.6494314725562678</c:v>
                </c:pt>
                <c:pt idx="10">
                  <c:v>1.7238053908095858</c:v>
                </c:pt>
                <c:pt idx="11">
                  <c:v>1.6876416413520421</c:v>
                </c:pt>
                <c:pt idx="12">
                  <c:v>1.5038881009439038</c:v>
                </c:pt>
                <c:pt idx="13">
                  <c:v>1.4672079033599061</c:v>
                </c:pt>
                <c:pt idx="14">
                  <c:v>1.2765353883977117</c:v>
                </c:pt>
                <c:pt idx="15">
                  <c:v>1.4892912864639971</c:v>
                </c:pt>
                <c:pt idx="16">
                  <c:v>1.8851159886652897</c:v>
                </c:pt>
                <c:pt idx="17">
                  <c:v>1.5849382834638106</c:v>
                </c:pt>
                <c:pt idx="18">
                  <c:v>1.2499404790248083</c:v>
                </c:pt>
                <c:pt idx="19">
                  <c:v>1.3927908194847864</c:v>
                </c:pt>
                <c:pt idx="20">
                  <c:v>1.0298037315241095</c:v>
                </c:pt>
                <c:pt idx="21">
                  <c:v>1.1267264356675553</c:v>
                </c:pt>
                <c:pt idx="22">
                  <c:v>1.085348981441725</c:v>
                </c:pt>
                <c:pt idx="23">
                  <c:v>1.3596679547731501</c:v>
                </c:pt>
                <c:pt idx="24">
                  <c:v>1.298014518532763</c:v>
                </c:pt>
                <c:pt idx="25">
                  <c:v>1.4182010480265372</c:v>
                </c:pt>
                <c:pt idx="26">
                  <c:v>1.8324484330216604</c:v>
                </c:pt>
                <c:pt idx="27">
                  <c:v>1.7502231828219705</c:v>
                </c:pt>
                <c:pt idx="28">
                  <c:v>1.6887902121026028</c:v>
                </c:pt>
                <c:pt idx="29">
                  <c:v>1.7124096556285133</c:v>
                </c:pt>
                <c:pt idx="30">
                  <c:v>1.5343085229108024</c:v>
                </c:pt>
                <c:pt idx="31">
                  <c:v>1.5689169858336025</c:v>
                </c:pt>
                <c:pt idx="32">
                  <c:v>1.4365769102911146</c:v>
                </c:pt>
                <c:pt idx="33">
                  <c:v>1.4009593009450541</c:v>
                </c:pt>
                <c:pt idx="34">
                  <c:v>1.4161322035485229</c:v>
                </c:pt>
                <c:pt idx="35">
                  <c:v>1.7555357895229622</c:v>
                </c:pt>
                <c:pt idx="36">
                  <c:v>1.1890463607975017</c:v>
                </c:pt>
                <c:pt idx="37">
                  <c:v>1.4172471775162143</c:v>
                </c:pt>
                <c:pt idx="38">
                  <c:v>1.2721738716887809</c:v>
                </c:pt>
                <c:pt idx="39">
                  <c:v>1.3316212488704997</c:v>
                </c:pt>
                <c:pt idx="40">
                  <c:v>1.6138287189786258</c:v>
                </c:pt>
                <c:pt idx="41">
                  <c:v>1.6138287189786258</c:v>
                </c:pt>
                <c:pt idx="42">
                  <c:v>1.7127332860855184</c:v>
                </c:pt>
                <c:pt idx="43">
                  <c:v>1.8308528230569336</c:v>
                </c:pt>
                <c:pt idx="44">
                  <c:v>1.8971434095413022</c:v>
                </c:pt>
                <c:pt idx="45">
                  <c:v>1.7642225337135677</c:v>
                </c:pt>
                <c:pt idx="46">
                  <c:v>1.4789253142716294</c:v>
                </c:pt>
                <c:pt idx="47">
                  <c:v>1.4666009366526991</c:v>
                </c:pt>
                <c:pt idx="48">
                  <c:v>1.7373506592412775</c:v>
                </c:pt>
                <c:pt idx="49">
                  <c:v>1.7254509971916798</c:v>
                </c:pt>
                <c:pt idx="50">
                  <c:v>1.4624123761179599</c:v>
                </c:pt>
                <c:pt idx="51">
                  <c:v>1.3415518491660623</c:v>
                </c:pt>
                <c:pt idx="52">
                  <c:v>1.6335124146943516</c:v>
                </c:pt>
                <c:pt idx="53">
                  <c:v>1.3189100237161802</c:v>
                </c:pt>
                <c:pt idx="54">
                  <c:v>1.3565426170468187</c:v>
                </c:pt>
                <c:pt idx="55">
                  <c:v>1.2004801920768307</c:v>
                </c:pt>
                <c:pt idx="56">
                  <c:v>2.0434348714536901</c:v>
                </c:pt>
                <c:pt idx="57">
                  <c:v>1.877108777265599</c:v>
                </c:pt>
                <c:pt idx="58">
                  <c:v>1.4017188289903029</c:v>
                </c:pt>
                <c:pt idx="59">
                  <c:v>1.482145319178271</c:v>
                </c:pt>
                <c:pt idx="60">
                  <c:v>1.7962656582368233</c:v>
                </c:pt>
                <c:pt idx="61">
                  <c:v>1.6426376743086739</c:v>
                </c:pt>
              </c:numCache>
            </c:numRef>
          </c:xVal>
          <c:yVal>
            <c:numRef>
              <c:f>Sheet1!$T$2:$T$63</c:f>
              <c:numCache>
                <c:formatCode>General</c:formatCode>
                <c:ptCount val="62"/>
                <c:pt idx="0">
                  <c:v>1.42</c:v>
                </c:pt>
                <c:pt idx="1">
                  <c:v>1.0900000000000001</c:v>
                </c:pt>
                <c:pt idx="2">
                  <c:v>1.1399999999999999</c:v>
                </c:pt>
                <c:pt idx="3">
                  <c:v>1.7</c:v>
                </c:pt>
                <c:pt idx="4">
                  <c:v>1.67</c:v>
                </c:pt>
                <c:pt idx="5">
                  <c:v>1.6</c:v>
                </c:pt>
                <c:pt idx="6">
                  <c:v>1.87</c:v>
                </c:pt>
                <c:pt idx="7">
                  <c:v>1.88</c:v>
                </c:pt>
                <c:pt idx="8">
                  <c:v>1.6</c:v>
                </c:pt>
                <c:pt idx="9">
                  <c:v>2.0299999999999998</c:v>
                </c:pt>
                <c:pt idx="10">
                  <c:v>1.89</c:v>
                </c:pt>
                <c:pt idx="11">
                  <c:v>1.64</c:v>
                </c:pt>
                <c:pt idx="12">
                  <c:v>1.38</c:v>
                </c:pt>
                <c:pt idx="13">
                  <c:v>1.48</c:v>
                </c:pt>
                <c:pt idx="14">
                  <c:v>1.0900000000000001</c:v>
                </c:pt>
                <c:pt idx="15">
                  <c:v>1.33</c:v>
                </c:pt>
                <c:pt idx="16">
                  <c:v>1.87</c:v>
                </c:pt>
                <c:pt idx="17">
                  <c:v>1.5</c:v>
                </c:pt>
                <c:pt idx="18">
                  <c:v>1.31</c:v>
                </c:pt>
                <c:pt idx="19">
                  <c:v>1.4</c:v>
                </c:pt>
                <c:pt idx="20">
                  <c:v>0.89</c:v>
                </c:pt>
                <c:pt idx="21">
                  <c:v>0.98</c:v>
                </c:pt>
                <c:pt idx="22">
                  <c:v>1.18</c:v>
                </c:pt>
                <c:pt idx="23">
                  <c:v>1.28</c:v>
                </c:pt>
                <c:pt idx="24">
                  <c:v>1.19</c:v>
                </c:pt>
                <c:pt idx="25">
                  <c:v>1.35</c:v>
                </c:pt>
                <c:pt idx="26">
                  <c:v>1.73</c:v>
                </c:pt>
                <c:pt idx="27">
                  <c:v>2.1</c:v>
                </c:pt>
                <c:pt idx="28">
                  <c:v>1.56</c:v>
                </c:pt>
                <c:pt idx="29">
                  <c:v>1.5</c:v>
                </c:pt>
                <c:pt idx="30">
                  <c:v>1.67</c:v>
                </c:pt>
                <c:pt idx="31">
                  <c:v>1.77</c:v>
                </c:pt>
                <c:pt idx="32">
                  <c:v>1.44</c:v>
                </c:pt>
                <c:pt idx="33">
                  <c:v>1.1000000000000001</c:v>
                </c:pt>
                <c:pt idx="34">
                  <c:v>1.49</c:v>
                </c:pt>
                <c:pt idx="35">
                  <c:v>2.17</c:v>
                </c:pt>
                <c:pt idx="36">
                  <c:v>1.1000000000000001</c:v>
                </c:pt>
                <c:pt idx="37">
                  <c:v>1.48</c:v>
                </c:pt>
                <c:pt idx="38">
                  <c:v>1.18</c:v>
                </c:pt>
                <c:pt idx="39">
                  <c:v>1.26</c:v>
                </c:pt>
                <c:pt idx="40">
                  <c:v>1.62</c:v>
                </c:pt>
                <c:pt idx="41">
                  <c:v>1.39</c:v>
                </c:pt>
                <c:pt idx="42">
                  <c:v>1.85</c:v>
                </c:pt>
                <c:pt idx="43">
                  <c:v>1.95</c:v>
                </c:pt>
                <c:pt idx="44">
                  <c:v>2.1</c:v>
                </c:pt>
                <c:pt idx="45">
                  <c:v>2.08</c:v>
                </c:pt>
                <c:pt idx="46">
                  <c:v>1.24</c:v>
                </c:pt>
                <c:pt idx="47">
                  <c:v>1.47</c:v>
                </c:pt>
                <c:pt idx="48">
                  <c:v>1.66</c:v>
                </c:pt>
                <c:pt idx="49">
                  <c:v>1.74</c:v>
                </c:pt>
                <c:pt idx="50">
                  <c:v>1.31</c:v>
                </c:pt>
                <c:pt idx="51">
                  <c:v>1.54</c:v>
                </c:pt>
                <c:pt idx="52">
                  <c:v>1.62</c:v>
                </c:pt>
                <c:pt idx="53">
                  <c:v>1.35</c:v>
                </c:pt>
                <c:pt idx="54">
                  <c:v>1.34</c:v>
                </c:pt>
                <c:pt idx="55">
                  <c:v>1.29</c:v>
                </c:pt>
                <c:pt idx="56">
                  <c:v>2.2999999999999998</c:v>
                </c:pt>
                <c:pt idx="57">
                  <c:v>1.9</c:v>
                </c:pt>
                <c:pt idx="58">
                  <c:v>1.35</c:v>
                </c:pt>
                <c:pt idx="59">
                  <c:v>1.55</c:v>
                </c:pt>
                <c:pt idx="60">
                  <c:v>1.74</c:v>
                </c:pt>
                <c:pt idx="61">
                  <c:v>1.54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[PUE1_Panalysis.xlsx]P-result (ADJUST)'!$W$1</c:f>
              <c:strCache>
                <c:ptCount val="1"/>
                <c:pt idx="0">
                  <c:v>#REF!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5"/>
            <c:spPr>
              <a:solidFill>
                <a:srgbClr val="FF00FF"/>
              </a:solidFill>
              <a:ln>
                <a:solidFill>
                  <a:srgbClr val="FF00FF"/>
                </a:solidFill>
                <a:prstDash val="solid"/>
              </a:ln>
            </c:spPr>
          </c:marker>
          <c:trendline>
            <c:spPr>
              <a:ln w="25400">
                <a:solidFill>
                  <a:srgbClr val="000000"/>
                </a:solidFill>
                <a:prstDash val="solid"/>
              </a:ln>
            </c:spPr>
            <c:trendlineType val="linear"/>
            <c:dispRSqr val="1"/>
            <c:dispEq val="0"/>
            <c:trendlineLbl>
              <c:layout>
                <c:manualLayout>
                  <c:x val="7.8308454328865879E-2"/>
                  <c:y val="0.27535489387290396"/>
                </c:manualLayout>
              </c:layout>
              <c:numFmt formatCode="General" sourceLinked="0"/>
              <c:spPr>
                <a:noFill/>
                <a:ln w="25400">
                  <a:noFill/>
                </a:ln>
              </c:spPr>
            </c:trendlineLbl>
          </c:trendline>
          <c:xVal>
            <c:numRef>
              <c:f>'[PUE1_Panalysis.xlsx]P-result (ADJUST)'!$T$2:$T$31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xVal>
          <c:yVal>
            <c:numRef>
              <c:f>'P-result (ADJUST)'!#REF!</c:f>
              <c:numCache>
                <c:formatCode>General</c:formatCode>
                <c:ptCount val="1"/>
                <c:pt idx="0">
                  <c:v>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00786560"/>
        <c:axId val="100788480"/>
      </c:scatterChart>
      <c:valAx>
        <c:axId val="100786560"/>
        <c:scaling>
          <c:orientation val="minMax"/>
          <c:max val="2.4"/>
          <c:min val="0.8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UE estimated based on P supplied</a:t>
                </a:r>
              </a:p>
            </c:rich>
          </c:tx>
          <c:layout>
            <c:manualLayout>
              <c:xMode val="edge"/>
              <c:yMode val="edge"/>
              <c:x val="0.32289336817312619"/>
              <c:y val="0.93742752525252515"/>
            </c:manualLayout>
          </c:layout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00788480"/>
        <c:crosses val="autoZero"/>
        <c:crossBetween val="midCat"/>
        <c:majorUnit val="0.4"/>
      </c:valAx>
      <c:valAx>
        <c:axId val="100788480"/>
        <c:scaling>
          <c:orientation val="minMax"/>
          <c:max val="2.4"/>
          <c:min val="0.8"/>
        </c:scaling>
        <c:delete val="0"/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PUE measured based on tissue P concentrations</a:t>
                </a:r>
              </a:p>
            </c:rich>
          </c:tx>
          <c:layout>
            <c:manualLayout>
              <c:xMode val="edge"/>
              <c:yMode val="edge"/>
              <c:x val="1.1037491812543671E-2"/>
              <c:y val="5.7715745316701178E-2"/>
            </c:manualLayout>
          </c:layout>
          <c:overlay val="0"/>
          <c:spPr>
            <a:noFill/>
            <a:ln w="25400">
              <a:noFill/>
            </a:ln>
          </c:spPr>
        </c:title>
        <c:numFmt formatCode="_(* #,##0.0_);_(* \(#,##0.0\);_(* &quot;-&quot;_);_(@_)" sourceLinked="0"/>
        <c:majorTickMark val="out"/>
        <c:minorTickMark val="none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100786560"/>
        <c:crosses val="autoZero"/>
        <c:crossBetween val="midCat"/>
        <c:majorUnit val="0.4"/>
      </c:valAx>
      <c:spPr>
        <a:noFill/>
        <a:ln w="12700">
          <a:solidFill>
            <a:srgbClr val="808080"/>
          </a:solidFill>
          <a:prstDash val="solid"/>
        </a:ln>
      </c:spPr>
    </c:plotArea>
    <c:plotVisOnly val="1"/>
    <c:dispBlanksAs val="gap"/>
    <c:showDLblsOverMax val="0"/>
  </c:chart>
  <c:spPr>
    <a:solidFill>
      <a:srgbClr val="FFFFFF"/>
    </a:solidFill>
    <a:ln w="3175">
      <a:solidFill>
        <a:srgbClr val="000000"/>
      </a:solidFill>
      <a:prstDash val="solid"/>
    </a:ln>
  </c:spPr>
  <c:txPr>
    <a:bodyPr/>
    <a:lstStyle/>
    <a:p>
      <a:pPr>
        <a:defRPr sz="1200" b="0" i="0" u="none" strike="noStrike" baseline="0">
          <a:solidFill>
            <a:srgbClr val="000000"/>
          </a:solidFill>
          <a:latin typeface="Times New Roman"/>
          <a:ea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243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3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4557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07710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41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693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3039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489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6644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749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06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2892F-BE3A-49C8-9604-C2C3D160806A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6DF236-13A0-4093-988F-8CADB87D2B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08789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44183" y="5029200"/>
            <a:ext cx="7848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3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PUE estimated based on P supply in nutrient solution an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eeds versus PUE measured based on analysis of P concentrations in root and shoot tissue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8" name="Char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1489616"/>
              </p:ext>
            </p:extLst>
          </p:nvPr>
        </p:nvGraphicFramePr>
        <p:xfrm>
          <a:off x="117441" y="932974"/>
          <a:ext cx="4455000" cy="39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6327776"/>
              </p:ext>
            </p:extLst>
          </p:nvPr>
        </p:nvGraphicFramePr>
        <p:xfrm>
          <a:off x="4648200" y="932974"/>
          <a:ext cx="4315372" cy="39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5410200" y="1067801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xp2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914400" y="1086783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xp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792886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58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7</cp:revision>
  <cp:lastPrinted>2013-05-14T02:18:48Z</cp:lastPrinted>
  <dcterms:created xsi:type="dcterms:W3CDTF">2013-03-27T02:02:51Z</dcterms:created>
  <dcterms:modified xsi:type="dcterms:W3CDTF">2015-02-19T02:26:00Z</dcterms:modified>
</cp:coreProperties>
</file>